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348" r:id="rId2"/>
    <p:sldId id="349" r:id="rId3"/>
    <p:sldId id="355" r:id="rId4"/>
    <p:sldId id="343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22F1BC4-7422-7150-6F98-3917B0BEF8DA}" name="종원 이" initials="종이" userId="76641029c0ca3949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/_학생_생명과학과" initials="/" lastIdx="1" clrIdx="0">
    <p:extLst>
      <p:ext uri="{19B8F6BF-5375-455C-9EA6-DF929625EA0E}">
        <p15:presenceInfo xmlns:p15="http://schemas.microsoft.com/office/powerpoint/2012/main" userId="/_학생_생명과학과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06" autoAdjust="0"/>
    <p:restoredTop sz="88667" autoAdjust="0"/>
  </p:normalViewPr>
  <p:slideViewPr>
    <p:cSldViewPr snapToGrid="0">
      <p:cViewPr varScale="1">
        <p:scale>
          <a:sx n="71" d="100"/>
          <a:sy n="71" d="100"/>
        </p:scale>
        <p:origin x="3246" y="60"/>
      </p:cViewPr>
      <p:guideLst/>
    </p:cSldViewPr>
  </p:slideViewPr>
  <p:notesTextViewPr>
    <p:cViewPr>
      <p:scale>
        <a:sx n="75" d="100"/>
        <a:sy n="75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Relationship Id="rId30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76ED42-C9D7-42B1-8EBD-6691B18E8CE2}" type="datetimeFigureOut">
              <a:rPr lang="ko-KR" altLang="en-US" smtClean="0"/>
              <a:t>2025-11-0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796B65-1DBC-42F2-9EA7-3D3167BB22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74910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9C96AA1-5650-8218-13A9-4395EAC0CE9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>
            <a:extLst>
              <a:ext uri="{FF2B5EF4-FFF2-40B4-BE49-F238E27FC236}">
                <a16:creationId xmlns:a16="http://schemas.microsoft.com/office/drawing/2014/main" id="{C2CD8D8D-F95A-8244-CC08-2558C69E397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>
            <a:extLst>
              <a:ext uri="{FF2B5EF4-FFF2-40B4-BE49-F238E27FC236}">
                <a16:creationId xmlns:a16="http://schemas.microsoft.com/office/drawing/2014/main" id="{5628DE21-849A-4DA6-E53E-97E8AEC7D7D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C182FA6D-B20D-C77B-B699-BD7027A621E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796B65-1DBC-42F2-9EA7-3D3167BB2230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82234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C03F688-EB6D-C34B-B53A-0DB4F701338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>
            <a:extLst>
              <a:ext uri="{FF2B5EF4-FFF2-40B4-BE49-F238E27FC236}">
                <a16:creationId xmlns:a16="http://schemas.microsoft.com/office/drawing/2014/main" id="{F3437D97-7350-5D8E-9314-9A36D8005C27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>
            <a:extLst>
              <a:ext uri="{FF2B5EF4-FFF2-40B4-BE49-F238E27FC236}">
                <a16:creationId xmlns:a16="http://schemas.microsoft.com/office/drawing/2014/main" id="{EC74CF26-32E2-E6F7-23DA-3EA8B3C1CB4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F7D2E722-6BF8-67A5-CA8E-A84E40327FA7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796B65-1DBC-42F2-9EA7-3D3167BB2230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484681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55EC3E5-19C7-0FAF-C97E-5A8AA08C575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>
            <a:extLst>
              <a:ext uri="{FF2B5EF4-FFF2-40B4-BE49-F238E27FC236}">
                <a16:creationId xmlns:a16="http://schemas.microsoft.com/office/drawing/2014/main" id="{CB9D177E-3071-CEA5-B307-928D7CCBC556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>
            <a:extLst>
              <a:ext uri="{FF2B5EF4-FFF2-40B4-BE49-F238E27FC236}">
                <a16:creationId xmlns:a16="http://schemas.microsoft.com/office/drawing/2014/main" id="{D00FBB6E-6604-13E7-D438-EC92C21BFF5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503E118-0E34-368D-38C9-A5F5E9B29A6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796B65-1DBC-42F2-9EA7-3D3167BB2230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735331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796B65-1DBC-42F2-9EA7-3D3167BB2230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35848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F5612-AAA9-4E32-8666-2312F88DA47A}" type="datetimeFigureOut">
              <a:rPr lang="ko-KR" altLang="en-US" smtClean="0"/>
              <a:t>2025-11-0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19DE8-C932-472B-9C23-5AB681755A0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9042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F5612-AAA9-4E32-8666-2312F88DA47A}" type="datetimeFigureOut">
              <a:rPr lang="ko-KR" altLang="en-US" smtClean="0"/>
              <a:t>2025-11-0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19DE8-C932-472B-9C23-5AB681755A0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0047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F5612-AAA9-4E32-8666-2312F88DA47A}" type="datetimeFigureOut">
              <a:rPr lang="ko-KR" altLang="en-US" smtClean="0"/>
              <a:t>2025-11-0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19DE8-C932-472B-9C23-5AB681755A0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7278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F5612-AAA9-4E32-8666-2312F88DA47A}" type="datetimeFigureOut">
              <a:rPr lang="ko-KR" altLang="en-US" smtClean="0"/>
              <a:t>2025-11-0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19DE8-C932-472B-9C23-5AB681755A0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8387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F5612-AAA9-4E32-8666-2312F88DA47A}" type="datetimeFigureOut">
              <a:rPr lang="ko-KR" altLang="en-US" smtClean="0"/>
              <a:t>2025-11-0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19DE8-C932-472B-9C23-5AB681755A0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49147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F5612-AAA9-4E32-8666-2312F88DA47A}" type="datetimeFigureOut">
              <a:rPr lang="ko-KR" altLang="en-US" smtClean="0"/>
              <a:t>2025-11-0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19DE8-C932-472B-9C23-5AB681755A0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56259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F5612-AAA9-4E32-8666-2312F88DA47A}" type="datetimeFigureOut">
              <a:rPr lang="ko-KR" altLang="en-US" smtClean="0"/>
              <a:t>2025-11-0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19DE8-C932-472B-9C23-5AB681755A0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2240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F5612-AAA9-4E32-8666-2312F88DA47A}" type="datetimeFigureOut">
              <a:rPr lang="ko-KR" altLang="en-US" smtClean="0"/>
              <a:t>2025-11-0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19DE8-C932-472B-9C23-5AB681755A0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43094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F5612-AAA9-4E32-8666-2312F88DA47A}" type="datetimeFigureOut">
              <a:rPr lang="ko-KR" altLang="en-US" smtClean="0"/>
              <a:t>2025-11-0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19DE8-C932-472B-9C23-5AB681755A0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9866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F5612-AAA9-4E32-8666-2312F88DA47A}" type="datetimeFigureOut">
              <a:rPr lang="ko-KR" altLang="en-US" smtClean="0"/>
              <a:t>2025-11-0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19DE8-C932-472B-9C23-5AB681755A0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2111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F5612-AAA9-4E32-8666-2312F88DA47A}" type="datetimeFigureOut">
              <a:rPr lang="ko-KR" altLang="en-US" smtClean="0"/>
              <a:t>2025-11-0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519DE8-C932-472B-9C23-5AB681755A0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69507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A8F5612-AAA9-4E32-8666-2312F88DA47A}" type="datetimeFigureOut">
              <a:rPr lang="ko-KR" altLang="en-US" smtClean="0"/>
              <a:t>2025-11-0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2519DE8-C932-472B-9C23-5AB681755A0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379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0967535-C298-ED88-630F-C0813B22D0B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4718916-CCA0-4C76-3B96-28233BD1E40B}"/>
              </a:ext>
            </a:extLst>
          </p:cNvPr>
          <p:cNvSpPr txBox="1"/>
          <p:nvPr/>
        </p:nvSpPr>
        <p:spPr>
          <a:xfrm>
            <a:off x="151547" y="150343"/>
            <a:ext cx="386890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그림 9">
            <a:extLst>
              <a:ext uri="{FF2B5EF4-FFF2-40B4-BE49-F238E27FC236}">
                <a16:creationId xmlns:a16="http://schemas.microsoft.com/office/drawing/2014/main" id="{B3D3F075-D2C0-450A-AC37-2F56E90B87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1547" y="1846004"/>
            <a:ext cx="6389162" cy="4907705"/>
          </a:xfrm>
          <a:prstGeom prst="rect">
            <a:avLst/>
          </a:prstGeom>
        </p:spPr>
      </p:pic>
      <p:sp>
        <p:nvSpPr>
          <p:cNvPr id="11" name="직사각형 10">
            <a:extLst>
              <a:ext uri="{FF2B5EF4-FFF2-40B4-BE49-F238E27FC236}">
                <a16:creationId xmlns:a16="http://schemas.microsoft.com/office/drawing/2014/main" id="{9657CD85-3FB7-4BAD-87CF-3DA720B8AE23}"/>
              </a:ext>
            </a:extLst>
          </p:cNvPr>
          <p:cNvSpPr/>
          <p:nvPr/>
        </p:nvSpPr>
        <p:spPr>
          <a:xfrm>
            <a:off x="350378" y="7810543"/>
            <a:ext cx="619033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altLang="ko-KR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Suppl. Fig. 1. 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(A) </a:t>
            </a:r>
            <a:r>
              <a:rPr lang="ko-KR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rgetP-2.0 </a:t>
            </a:r>
            <a:r>
              <a:rPr lang="ko-KR" altLang="ko-KR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diction</a:t>
            </a:r>
            <a:r>
              <a:rPr lang="ko-KR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ko-KR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ko-KR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gnal</a:t>
            </a:r>
            <a:r>
              <a:rPr lang="ko-KR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ptide</a:t>
            </a:r>
            <a:r>
              <a:rPr lang="ko-KR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(</a:t>
            </a:r>
            <a:r>
              <a:rPr lang="ko-KR" altLang="ko-KR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ko-KR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TMHHM-2.0 </a:t>
            </a:r>
            <a:r>
              <a:rPr lang="ko-KR" altLang="ko-KR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diction</a:t>
            </a:r>
            <a:r>
              <a:rPr lang="ko-KR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ko-KR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ansmembrane</a:t>
            </a:r>
            <a:r>
              <a:rPr lang="ko-KR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lices</a:t>
            </a:r>
            <a:r>
              <a:rPr lang="ko-KR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ko-KR" altLang="ko-KR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ko-KR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bHsp104 </a:t>
            </a:r>
            <a:r>
              <a:rPr lang="ko-KR" altLang="ko-KR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dentified</a:t>
            </a:r>
            <a:r>
              <a:rPr lang="ko-KR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ko-KR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ko-KR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rine</a:t>
            </a:r>
            <a:r>
              <a:rPr lang="ko-KR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atom</a:t>
            </a:r>
            <a:r>
              <a:rPr lang="ko-KR" altLang="ko-KR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i="1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tylum brightwellii.</a:t>
            </a:r>
            <a:endParaRPr lang="ko-KR" altLang="ko-KR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3621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CB0F559-863D-FF6C-5E07-9C7B085B197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C76AE89-F622-97CC-7A38-B761D3F545C4}"/>
              </a:ext>
            </a:extLst>
          </p:cNvPr>
          <p:cNvSpPr txBox="1"/>
          <p:nvPr/>
        </p:nvSpPr>
        <p:spPr>
          <a:xfrm>
            <a:off x="151547" y="150343"/>
            <a:ext cx="386890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그림 10" descr="텍스트, 스크린샷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1DF28ABB-EC1F-3101-1096-3FE4EA19D3B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592" y="2878836"/>
            <a:ext cx="5766816" cy="4148328"/>
          </a:xfrm>
          <a:prstGeom prst="rect">
            <a:avLst/>
          </a:prstGeom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C8829B8D-C1FC-4175-A6FA-C2BB59DB0ACE}"/>
              </a:ext>
            </a:extLst>
          </p:cNvPr>
          <p:cNvSpPr/>
          <p:nvPr/>
        </p:nvSpPr>
        <p:spPr>
          <a:xfrm>
            <a:off x="350378" y="7810543"/>
            <a:ext cx="6190331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main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ganization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(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ee-dimensional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ucture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3D) of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bHsp104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dentified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ine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atom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tylum brightwellii. 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D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ucture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DbHsp104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r-coded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mains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-terminal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main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TD,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ange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cleotide-binding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main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(NBD1,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ue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ddle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main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D,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een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NBD2 (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rple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C-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minal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main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TD,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own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797499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8007C0D-B06E-0FC8-7AFD-E6835050B79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6E98C6A-A66E-88B2-614E-F7F10E034C76}"/>
              </a:ext>
            </a:extLst>
          </p:cNvPr>
          <p:cNvSpPr txBox="1"/>
          <p:nvPr/>
        </p:nvSpPr>
        <p:spPr>
          <a:xfrm>
            <a:off x="151547" y="150343"/>
            <a:ext cx="386890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그림 4" descr="텍스트, 스크린샷, 그래프, 도표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72B11B60-AFDC-93C1-91BB-51566E6AB28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167" y="2199860"/>
            <a:ext cx="6359665" cy="4293117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13B0FC98-8A62-43D7-897A-1562E44F28CA}"/>
              </a:ext>
            </a:extLst>
          </p:cNvPr>
          <p:cNvSpPr/>
          <p:nvPr/>
        </p:nvSpPr>
        <p:spPr>
          <a:xfrm>
            <a:off x="350378" y="7810543"/>
            <a:ext cx="6190331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3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due confidence profiles for the five top-ranked AlphaFold2 models of DbHsp104. The plot shows predicted IDDT (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DDT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values for residues 1–915 aa on the x-axis and scores from 0–100 on the y-axis (≥90, very high; 70–90, high; &lt;70, moderate–low confidence). Curves for rank 1–5 (blue, orange, green, red, purple) overlap across the sequence.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938629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9556491-6AA2-5D8E-9CAE-2C97243DC0AD}"/>
              </a:ext>
            </a:extLst>
          </p:cNvPr>
          <p:cNvSpPr txBox="1"/>
          <p:nvPr/>
        </p:nvSpPr>
        <p:spPr>
          <a:xfrm>
            <a:off x="151547" y="150343"/>
            <a:ext cx="386890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그림 9" descr="텍스트, 도표, 지도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8F1CEF38-2FA3-2B52-91E1-A56899EC206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2393" y="1130900"/>
            <a:ext cx="5053213" cy="6991914"/>
          </a:xfrm>
          <a:prstGeom prst="rect">
            <a:avLst/>
          </a:prstGeom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0BAE4F43-FFDB-4FBD-8CD8-CE36E0AC2F67}"/>
              </a:ext>
            </a:extLst>
          </p:cNvPr>
          <p:cNvSpPr/>
          <p:nvPr/>
        </p:nvSpPr>
        <p:spPr>
          <a:xfrm>
            <a:off x="350378" y="8605304"/>
            <a:ext cx="6190331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4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erved residues mapped onto the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ee-dimensional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3D)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DbHsp104. (A) Overview of residues of nucleotide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nding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main</a:t>
            </a:r>
            <a:r>
              <a:rPr lang="ko-K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(NBD1)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B) Walker A motif (orange), Walker B motif (blue), and conserved arginine finger (yellow). (C) Overview of residues of NBD2. (D) Hexamer interface (red). (E) Overview of ATP binding sites. (F) Specific ATP binding site (black)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5558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574</TotalTime>
  <Words>294</Words>
  <Application>Microsoft Office PowerPoint</Application>
  <PresentationFormat>A4 용지(210x297mm)</PresentationFormat>
  <Paragraphs>12</Paragraphs>
  <Slides>4</Slides>
  <Notes>4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11" baseType="lpstr">
      <vt:lpstr>Aptos</vt:lpstr>
      <vt:lpstr>Aptos Display</vt:lpstr>
      <vt:lpstr>맑은 고딕</vt:lpstr>
      <vt:lpstr>바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olecular cloning of heat shock protein 104 (Hsp104) in the marine diatom Ditylum brightwellii and transcriptional responses to environmental stresses</dc:title>
  <dc:creator>종원 이</dc:creator>
  <cp:lastModifiedBy>sol29</cp:lastModifiedBy>
  <cp:revision>103</cp:revision>
  <dcterms:created xsi:type="dcterms:W3CDTF">2025-01-21T21:50:33Z</dcterms:created>
  <dcterms:modified xsi:type="dcterms:W3CDTF">2025-11-04T11:31:18Z</dcterms:modified>
</cp:coreProperties>
</file>